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26" d="100"/>
          <a:sy n="126" d="100"/>
        </p:scale>
        <p:origin x="978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562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060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4451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006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401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756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396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936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221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909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339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C6ED4-90D8-4763-BA8E-3A0595D662F1}" type="datetimeFigureOut">
              <a:rPr lang="en-US" smtClean="0"/>
              <a:t>9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4A1AE-F2CE-4772-99BC-63909B5DEA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105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B99E3CB-9CC6-4A85-9F5F-5DEC455AE6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3778913"/>
              </p:ext>
            </p:extLst>
          </p:nvPr>
        </p:nvGraphicFramePr>
        <p:xfrm>
          <a:off x="1285875" y="915354"/>
          <a:ext cx="3453448" cy="2425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Prism 8" r:id="rId3" imgW="3919717" imgH="2753378" progId="Prism8.Document">
                  <p:embed/>
                </p:oleObj>
              </mc:Choice>
              <mc:Fallback>
                <p:oleObj name="Prism 8" r:id="rId3" imgW="3919717" imgH="275337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85875" y="915354"/>
                        <a:ext cx="3453448" cy="24253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773DC50-C15D-4A54-B680-49DDD60865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3807195"/>
              </p:ext>
            </p:extLst>
          </p:nvPr>
        </p:nvGraphicFramePr>
        <p:xfrm>
          <a:off x="4859973" y="915354"/>
          <a:ext cx="3453447" cy="2425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3" name="Prism 8" r:id="rId5" imgW="3919717" imgH="2753378" progId="Prism8.Document">
                  <p:embed/>
                </p:oleObj>
              </mc:Choice>
              <mc:Fallback>
                <p:oleObj name="Prism 8" r:id="rId5" imgW="3919717" imgH="2753378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B99E3CB-9CC6-4A85-9F5F-5DEC455AE6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59973" y="915354"/>
                        <a:ext cx="3453447" cy="24253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042E416-C7ED-40E3-833A-32AF1D27B6AE}"/>
              </a:ext>
            </a:extLst>
          </p:cNvPr>
          <p:cNvSpPr txBox="1"/>
          <p:nvPr/>
        </p:nvSpPr>
        <p:spPr>
          <a:xfrm>
            <a:off x="1171575" y="556380"/>
            <a:ext cx="16880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. All S2 (NY, n=119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DC7B094-D4F6-4AC5-BE99-46EAA4C8DF1F}"/>
              </a:ext>
            </a:extLst>
          </p:cNvPr>
          <p:cNvSpPr txBox="1"/>
          <p:nvPr/>
        </p:nvSpPr>
        <p:spPr>
          <a:xfrm>
            <a:off x="4806633" y="556380"/>
            <a:ext cx="16009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. All S2 (BD, n=29)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66805D39-CF40-4A81-9AB6-5B6BB65D36E9}"/>
              </a:ext>
            </a:extLst>
          </p:cNvPr>
          <p:cNvCxnSpPr/>
          <p:nvPr/>
        </p:nvCxnSpPr>
        <p:spPr>
          <a:xfrm>
            <a:off x="2068735" y="2116455"/>
            <a:ext cx="2358485" cy="0"/>
          </a:xfrm>
          <a:prstGeom prst="line">
            <a:avLst/>
          </a:prstGeom>
          <a:ln w="12700">
            <a:solidFill>
              <a:schemeClr val="tx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4409313-C80D-4AA5-9944-4A1740058944}"/>
              </a:ext>
            </a:extLst>
          </p:cNvPr>
          <p:cNvCxnSpPr>
            <a:cxnSpLocks/>
          </p:cNvCxnSpPr>
          <p:nvPr/>
        </p:nvCxnSpPr>
        <p:spPr>
          <a:xfrm>
            <a:off x="5606733" y="2345055"/>
            <a:ext cx="2213705" cy="0"/>
          </a:xfrm>
          <a:prstGeom prst="line">
            <a:avLst/>
          </a:prstGeom>
          <a:ln w="12700">
            <a:solidFill>
              <a:schemeClr val="tx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FEDBC02-665E-4A64-82E0-4E2E08E143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6877782"/>
              </p:ext>
            </p:extLst>
          </p:nvPr>
        </p:nvGraphicFramePr>
        <p:xfrm>
          <a:off x="1330960" y="3769678"/>
          <a:ext cx="3363913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" name="Prism 8" r:id="rId7" imgW="3819239" imgH="2509553" progId="Prism8.Document">
                  <p:embed/>
                </p:oleObj>
              </mc:Choice>
              <mc:Fallback>
                <p:oleObj name="Prism 8" r:id="rId7" imgW="3819239" imgH="2509553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B99E3CB-9CC6-4A85-9F5F-5DEC455AE6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30960" y="3769678"/>
                        <a:ext cx="3363913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AFBEF16-257D-4DA5-867B-2CADD65D7D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8115283"/>
              </p:ext>
            </p:extLst>
          </p:nvPr>
        </p:nvGraphicFramePr>
        <p:xfrm>
          <a:off x="4956810" y="3769678"/>
          <a:ext cx="3363913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5" name="Prism 8" r:id="rId9" imgW="3819239" imgH="2509553" progId="Prism8.Document">
                  <p:embed/>
                </p:oleObj>
              </mc:Choice>
              <mc:Fallback>
                <p:oleObj name="Prism 8" r:id="rId9" imgW="3819239" imgH="2509553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0FEDBC02-665E-4A64-82E0-4E2E08E143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956810" y="3769678"/>
                        <a:ext cx="3363913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4E74C70A-9C7E-4046-B293-F3B100189D68}"/>
              </a:ext>
            </a:extLst>
          </p:cNvPr>
          <p:cNvSpPr txBox="1"/>
          <p:nvPr/>
        </p:nvSpPr>
        <p:spPr>
          <a:xfrm>
            <a:off x="1171575" y="3449361"/>
            <a:ext cx="2590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. Selected S2 for Ads (NY, n=18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186CCFA-3286-4132-B920-DBB192C46B3B}"/>
              </a:ext>
            </a:extLst>
          </p:cNvPr>
          <p:cNvSpPr txBox="1"/>
          <p:nvPr/>
        </p:nvSpPr>
        <p:spPr>
          <a:xfrm>
            <a:off x="4806633" y="3449361"/>
            <a:ext cx="26196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. Selected S2 for Ads (BD, n=14)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25F73D2-2388-493B-87E4-841172F21363}"/>
              </a:ext>
            </a:extLst>
          </p:cNvPr>
          <p:cNvSpPr/>
          <p:nvPr/>
        </p:nvSpPr>
        <p:spPr>
          <a:xfrm>
            <a:off x="1589786" y="5925944"/>
            <a:ext cx="6540373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>
                <a:ea typeface="Times New Roman" panose="02020603050405020304" pitchFamily="18" charset="0"/>
              </a:rPr>
              <a:t>FIGURE S1. </a:t>
            </a:r>
            <a:r>
              <a:rPr lang="en-US" sz="1400" dirty="0">
                <a:ea typeface="Times New Roman" panose="02020603050405020304" pitchFamily="18" charset="0"/>
              </a:rPr>
              <a:t>S2 serum sample were selected by sorting MFI values against homologues </a:t>
            </a:r>
            <a:r>
              <a:rPr lang="en-US" sz="1400" dirty="0" err="1">
                <a:ea typeface="Times New Roman" panose="02020603050405020304" pitchFamily="18" charset="0"/>
              </a:rPr>
              <a:t>rHAs</a:t>
            </a:r>
            <a:r>
              <a:rPr lang="en-US" sz="1400" dirty="0">
                <a:ea typeface="Times New Roman" panose="02020603050405020304" pitchFamily="18" charset="0"/>
              </a:rPr>
              <a:t> (A and C) for 2-Ads. Only MN titers against homologues viruses from selected S2 samples for 2-Ads were shown (B and D). </a:t>
            </a:r>
          </a:p>
        </p:txBody>
      </p:sp>
    </p:spTree>
    <p:extLst>
      <p:ext uri="{BB962C8B-B14F-4D97-AF65-F5344CB8AC3E}">
        <p14:creationId xmlns:p14="http://schemas.microsoft.com/office/powerpoint/2010/main" val="220379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</TotalTime>
  <Words>9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Zhunan (CDC/DDID/NCIRD/ID)</dc:creator>
  <cp:lastModifiedBy>Li, Zhunan (CDC/DDID/NCIRD/ID)</cp:lastModifiedBy>
  <cp:revision>12</cp:revision>
  <cp:lastPrinted>2019-09-17T14:17:25Z</cp:lastPrinted>
  <dcterms:created xsi:type="dcterms:W3CDTF">2019-09-16T20:20:13Z</dcterms:created>
  <dcterms:modified xsi:type="dcterms:W3CDTF">2019-09-19T14:20:45Z</dcterms:modified>
</cp:coreProperties>
</file>